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48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paper\M%20domain%20project\gel%20shift\hCTE%20binding%20titeration%20human%20and%20Ct%20protei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scatterChart>
        <c:scatterStyle val="smoothMarker"/>
        <c:ser>
          <c:idx val="0"/>
          <c:order val="0"/>
          <c:tx>
            <c:strRef>
              <c:f>'Ct proteins'!$K$11</c:f>
              <c:strCache>
                <c:ptCount val="1"/>
                <c:pt idx="0">
                  <c:v>deltaN</c:v>
                </c:pt>
              </c:strCache>
            </c:strRef>
          </c:tx>
          <c:spPr>
            <a:ln w="25400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t proteins'!$K$23:$K$31</c:f>
                <c:numCache>
                  <c:formatCode>General</c:formatCode>
                  <c:ptCount val="9"/>
                  <c:pt idx="0">
                    <c:v>0.94656199999999957</c:v>
                  </c:pt>
                  <c:pt idx="1">
                    <c:v>1.6928350000000001</c:v>
                  </c:pt>
                  <c:pt idx="2">
                    <c:v>1.5163549999999999</c:v>
                  </c:pt>
                  <c:pt idx="3">
                    <c:v>0.35904700000000001</c:v>
                  </c:pt>
                  <c:pt idx="4">
                    <c:v>0.49140800000000306</c:v>
                  </c:pt>
                  <c:pt idx="5">
                    <c:v>1.050867</c:v>
                  </c:pt>
                </c:numCache>
              </c:numRef>
            </c:plus>
            <c:minus>
              <c:numRef>
                <c:f>'Ct proteins'!$K$23:$K$31</c:f>
                <c:numCache>
                  <c:formatCode>General</c:formatCode>
                  <c:ptCount val="9"/>
                  <c:pt idx="0">
                    <c:v>0.94656199999999957</c:v>
                  </c:pt>
                  <c:pt idx="1">
                    <c:v>1.6928350000000001</c:v>
                  </c:pt>
                  <c:pt idx="2">
                    <c:v>1.5163549999999999</c:v>
                  </c:pt>
                  <c:pt idx="3">
                    <c:v>0.35904700000000001</c:v>
                  </c:pt>
                  <c:pt idx="4">
                    <c:v>0.49140800000000306</c:v>
                  </c:pt>
                  <c:pt idx="5">
                    <c:v>1.050867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xVal>
            <c:numRef>
              <c:f>'Ct proteins'!$J$12:$J$20</c:f>
              <c:numCache>
                <c:formatCode>General</c:formatCode>
                <c:ptCount val="9"/>
                <c:pt idx="0">
                  <c:v>6.8200000000000011E-2</c:v>
                </c:pt>
                <c:pt idx="1">
                  <c:v>0.13639999999999999</c:v>
                </c:pt>
                <c:pt idx="2">
                  <c:v>0.2727</c:v>
                </c:pt>
                <c:pt idx="3">
                  <c:v>0.54549999999999998</c:v>
                </c:pt>
                <c:pt idx="4">
                  <c:v>1.0909</c:v>
                </c:pt>
                <c:pt idx="5">
                  <c:v>2.1818</c:v>
                </c:pt>
                <c:pt idx="6">
                  <c:v>4.3635999999999955</c:v>
                </c:pt>
                <c:pt idx="7">
                  <c:v>8.7272999999999996</c:v>
                </c:pt>
                <c:pt idx="8">
                  <c:v>17.454599999999989</c:v>
                </c:pt>
              </c:numCache>
            </c:numRef>
          </c:xVal>
          <c:yVal>
            <c:numRef>
              <c:f>'Ct proteins'!$K$12:$K$20</c:f>
              <c:numCache>
                <c:formatCode>General</c:formatCode>
                <c:ptCount val="9"/>
                <c:pt idx="0">
                  <c:v>9.3803380000000001</c:v>
                </c:pt>
                <c:pt idx="1">
                  <c:v>20.598990000000001</c:v>
                </c:pt>
                <c:pt idx="2">
                  <c:v>54.973330000000011</c:v>
                </c:pt>
                <c:pt idx="3">
                  <c:v>68.129049999999978</c:v>
                </c:pt>
                <c:pt idx="4">
                  <c:v>82.886449999999982</c:v>
                </c:pt>
                <c:pt idx="5">
                  <c:v>87.79907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Ct proteins'!$L$11</c:f>
              <c:strCache>
                <c:ptCount val="1"/>
                <c:pt idx="0">
                  <c:v>NTF2/Mtr</c:v>
                </c:pt>
              </c:strCache>
            </c:strRef>
          </c:tx>
          <c:spPr>
            <a:ln w="25400">
              <a:solidFill>
                <a:prstClr val="black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t proteins'!$L$23:$L$31</c:f>
                <c:numCache>
                  <c:formatCode>General</c:formatCode>
                  <c:ptCount val="9"/>
                  <c:pt idx="2">
                    <c:v>0.33255800000000352</c:v>
                  </c:pt>
                  <c:pt idx="3">
                    <c:v>2.1977570000000002</c:v>
                  </c:pt>
                  <c:pt idx="4">
                    <c:v>2.6257389999999998</c:v>
                  </c:pt>
                  <c:pt idx="5">
                    <c:v>0.98852099999999388</c:v>
                  </c:pt>
                  <c:pt idx="6">
                    <c:v>0.77160800000000773</c:v>
                  </c:pt>
                  <c:pt idx="7">
                    <c:v>0.55499500000000612</c:v>
                  </c:pt>
                </c:numCache>
              </c:numRef>
            </c:plus>
            <c:minus>
              <c:numRef>
                <c:f>'Ct proteins'!$L$23:$L$31</c:f>
                <c:numCache>
                  <c:formatCode>General</c:formatCode>
                  <c:ptCount val="9"/>
                  <c:pt idx="2">
                    <c:v>0.33255800000000352</c:v>
                  </c:pt>
                  <c:pt idx="3">
                    <c:v>2.1977570000000002</c:v>
                  </c:pt>
                  <c:pt idx="4">
                    <c:v>2.6257389999999998</c:v>
                  </c:pt>
                  <c:pt idx="5">
                    <c:v>0.98852099999999388</c:v>
                  </c:pt>
                  <c:pt idx="6">
                    <c:v>0.77160800000000773</c:v>
                  </c:pt>
                  <c:pt idx="7">
                    <c:v>0.55499500000000612</c:v>
                  </c:pt>
                </c:numCache>
              </c:numRef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xVal>
            <c:numRef>
              <c:f>'Ct proteins'!$J$12:$J$20</c:f>
              <c:numCache>
                <c:formatCode>General</c:formatCode>
                <c:ptCount val="9"/>
                <c:pt idx="0">
                  <c:v>6.8200000000000011E-2</c:v>
                </c:pt>
                <c:pt idx="1">
                  <c:v>0.13639999999999999</c:v>
                </c:pt>
                <c:pt idx="2">
                  <c:v>0.2727</c:v>
                </c:pt>
                <c:pt idx="3">
                  <c:v>0.54549999999999998</c:v>
                </c:pt>
                <c:pt idx="4">
                  <c:v>1.0909</c:v>
                </c:pt>
                <c:pt idx="5">
                  <c:v>2.1818</c:v>
                </c:pt>
                <c:pt idx="6">
                  <c:v>4.3635999999999955</c:v>
                </c:pt>
                <c:pt idx="7">
                  <c:v>8.7272999999999996</c:v>
                </c:pt>
                <c:pt idx="8">
                  <c:v>17.454599999999989</c:v>
                </c:pt>
              </c:numCache>
            </c:numRef>
          </c:xVal>
          <c:yVal>
            <c:numRef>
              <c:f>'Ct proteins'!$L$12:$L$20</c:f>
              <c:numCache>
                <c:formatCode>General</c:formatCode>
                <c:ptCount val="9"/>
                <c:pt idx="2">
                  <c:v>5.9770300000000001</c:v>
                </c:pt>
                <c:pt idx="3">
                  <c:v>21.182779999999774</c:v>
                </c:pt>
                <c:pt idx="4">
                  <c:v>42.684989999999999</c:v>
                </c:pt>
                <c:pt idx="5">
                  <c:v>76.442930000000004</c:v>
                </c:pt>
                <c:pt idx="6">
                  <c:v>86.043180000000007</c:v>
                </c:pt>
                <c:pt idx="7">
                  <c:v>89.25202999999999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Ct proteins'!$M$11</c:f>
              <c:strCache>
                <c:ptCount val="1"/>
                <c:pt idx="0">
                  <c:v>RBD</c:v>
                </c:pt>
              </c:strCache>
            </c:strRef>
          </c:tx>
          <c:spPr>
            <a:ln w="25400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t proteins'!$M$23:$M$31</c:f>
                <c:numCache>
                  <c:formatCode>General</c:formatCode>
                  <c:ptCount val="9"/>
                  <c:pt idx="3">
                    <c:v>1.2081170000000001</c:v>
                  </c:pt>
                  <c:pt idx="4">
                    <c:v>1.066825699999987</c:v>
                  </c:pt>
                  <c:pt idx="5">
                    <c:v>1.8291095999999998</c:v>
                  </c:pt>
                  <c:pt idx="6">
                    <c:v>7.2311603000000124</c:v>
                  </c:pt>
                  <c:pt idx="7">
                    <c:v>4.3020234999999998</c:v>
                  </c:pt>
                  <c:pt idx="8">
                    <c:v>2.1181502000000001</c:v>
                  </c:pt>
                </c:numCache>
              </c:numRef>
            </c:plus>
            <c:minus>
              <c:numRef>
                <c:f>'Ct proteins'!$M$23:$M$31</c:f>
                <c:numCache>
                  <c:formatCode>General</c:formatCode>
                  <c:ptCount val="9"/>
                  <c:pt idx="3">
                    <c:v>1.2081170000000001</c:v>
                  </c:pt>
                  <c:pt idx="4">
                    <c:v>1.066825699999987</c:v>
                  </c:pt>
                  <c:pt idx="5">
                    <c:v>1.8291095999999998</c:v>
                  </c:pt>
                  <c:pt idx="6">
                    <c:v>7.2311603000000124</c:v>
                  </c:pt>
                  <c:pt idx="7">
                    <c:v>4.3020234999999998</c:v>
                  </c:pt>
                  <c:pt idx="8">
                    <c:v>2.1181502000000001</c:v>
                  </c:pt>
                </c:numCache>
              </c:numRef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xVal>
            <c:numRef>
              <c:f>'Ct proteins'!$J$12:$J$20</c:f>
              <c:numCache>
                <c:formatCode>General</c:formatCode>
                <c:ptCount val="9"/>
                <c:pt idx="0">
                  <c:v>6.8200000000000011E-2</c:v>
                </c:pt>
                <c:pt idx="1">
                  <c:v>0.13639999999999999</c:v>
                </c:pt>
                <c:pt idx="2">
                  <c:v>0.2727</c:v>
                </c:pt>
                <c:pt idx="3">
                  <c:v>0.54549999999999998</c:v>
                </c:pt>
                <c:pt idx="4">
                  <c:v>1.0909</c:v>
                </c:pt>
                <c:pt idx="5">
                  <c:v>2.1818</c:v>
                </c:pt>
                <c:pt idx="6">
                  <c:v>4.3635999999999955</c:v>
                </c:pt>
                <c:pt idx="7">
                  <c:v>8.7272999999999996</c:v>
                </c:pt>
                <c:pt idx="8">
                  <c:v>17.454599999999989</c:v>
                </c:pt>
              </c:numCache>
            </c:numRef>
          </c:xVal>
          <c:yVal>
            <c:numRef>
              <c:f>'Ct proteins'!$M$12:$M$20</c:f>
              <c:numCache>
                <c:formatCode>General</c:formatCode>
                <c:ptCount val="9"/>
                <c:pt idx="3">
                  <c:v>8.0023358000000027</c:v>
                </c:pt>
                <c:pt idx="4">
                  <c:v>18.678645999999986</c:v>
                </c:pt>
                <c:pt idx="5">
                  <c:v>47.699538000000473</c:v>
                </c:pt>
                <c:pt idx="6">
                  <c:v>55.973327000000005</c:v>
                </c:pt>
                <c:pt idx="7">
                  <c:v>72.042439000000002</c:v>
                </c:pt>
                <c:pt idx="8">
                  <c:v>68.97893999999998</c:v>
                </c:pt>
              </c:numCache>
            </c:numRef>
          </c:yVal>
          <c:smooth val="1"/>
        </c:ser>
        <c:axId val="165810560"/>
        <c:axId val="165812096"/>
      </c:scatterChart>
      <c:valAx>
        <c:axId val="165810560"/>
        <c:scaling>
          <c:orientation val="minMax"/>
        </c:scaling>
        <c:axPos val="b"/>
        <c:numFmt formatCode="General" sourceLinked="1"/>
        <c:tickLblPos val="nextTo"/>
        <c:spPr>
          <a:ln w="25400"/>
        </c:spPr>
        <c:txPr>
          <a:bodyPr/>
          <a:lstStyle/>
          <a:p>
            <a:pPr>
              <a:defRPr sz="1200" baseline="0">
                <a:latin typeface="Arial" pitchFamily="34" charset="0"/>
              </a:defRPr>
            </a:pPr>
            <a:endParaRPr lang="ja-JP"/>
          </a:p>
        </c:txPr>
        <c:crossAx val="165812096"/>
        <c:crosses val="autoZero"/>
        <c:crossBetween val="midCat"/>
      </c:valAx>
      <c:valAx>
        <c:axId val="165812096"/>
        <c:scaling>
          <c:orientation val="minMax"/>
        </c:scaling>
        <c:axPos val="l"/>
        <c:numFmt formatCode="General" sourceLinked="1"/>
        <c:tickLblPos val="nextTo"/>
        <c:spPr>
          <a:ln w="25400"/>
        </c:spPr>
        <c:txPr>
          <a:bodyPr/>
          <a:lstStyle/>
          <a:p>
            <a:pPr>
              <a:defRPr sz="1200" baseline="0">
                <a:latin typeface="Arial" pitchFamily="34" charset="0"/>
              </a:defRPr>
            </a:pPr>
            <a:endParaRPr lang="ja-JP"/>
          </a:p>
        </c:txPr>
        <c:crossAx val="165810560"/>
        <c:crosses val="autoZero"/>
        <c:crossBetween val="midCat"/>
        <c:majorUnit val="20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EB35C7-B95B-46B0-9D3A-AF2D11464467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19D9C-3269-4F0F-BC72-698A15AE703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tiff"/><Relationship Id="rId7" Type="http://schemas.openxmlformats.org/officeDocument/2006/relationships/image" Target="../media/image10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tiff"/><Relationship Id="rId4" Type="http://schemas.openxmlformats.org/officeDocument/2006/relationships/image" Target="../media/image7.tiff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221088" y="-36512"/>
            <a:ext cx="2669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upplementary Figure S1. Katahira et al.</a:t>
            </a:r>
            <a:endParaRPr kumimoji="1" lang="ja-JP" altLang="en-US" sz="1200" dirty="0"/>
          </a:p>
        </p:txBody>
      </p:sp>
      <p:grpSp>
        <p:nvGrpSpPr>
          <p:cNvPr id="3" name="グループ化 71"/>
          <p:cNvGrpSpPr/>
          <p:nvPr/>
        </p:nvGrpSpPr>
        <p:grpSpPr>
          <a:xfrm>
            <a:off x="44624" y="1191895"/>
            <a:ext cx="2595737" cy="3884161"/>
            <a:chOff x="404664" y="-58663"/>
            <a:chExt cx="2595737" cy="3884161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80728" y="1062557"/>
              <a:ext cx="1080120" cy="2501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" name="テキスト ボックス 15"/>
            <p:cNvSpPr txBox="1"/>
            <p:nvPr/>
          </p:nvSpPr>
          <p:spPr>
            <a:xfrm rot="18717735">
              <a:off x="1057299" y="459756"/>
              <a:ext cx="1165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70-657/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 rot="18717735">
              <a:off x="1475080" y="647492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93-360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rot="18717735">
              <a:off x="1613929" y="428169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365-564/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" name="直線コネクタ 30"/>
            <p:cNvCxnSpPr/>
            <p:nvPr/>
          </p:nvCxnSpPr>
          <p:spPr>
            <a:xfrm flipH="1">
              <a:off x="764704" y="1455911"/>
              <a:ext cx="2160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 flipH="1">
              <a:off x="764704" y="1711425"/>
              <a:ext cx="2160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/>
            <p:cNvCxnSpPr/>
            <p:nvPr/>
          </p:nvCxnSpPr>
          <p:spPr>
            <a:xfrm flipH="1">
              <a:off x="764704" y="1907704"/>
              <a:ext cx="2160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/>
            <p:cNvCxnSpPr/>
            <p:nvPr/>
          </p:nvCxnSpPr>
          <p:spPr>
            <a:xfrm flipH="1">
              <a:off x="764704" y="2339752"/>
              <a:ext cx="2160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 flipH="1">
              <a:off x="764704" y="2555776"/>
              <a:ext cx="2160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 flipH="1">
              <a:off x="764704" y="2915816"/>
              <a:ext cx="2160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テキスト ボックス 36"/>
            <p:cNvSpPr txBox="1"/>
            <p:nvPr/>
          </p:nvSpPr>
          <p:spPr>
            <a:xfrm>
              <a:off x="404664" y="123988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404664" y="1547664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50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404664" y="176368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38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404664" y="212372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404664" y="241176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20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404664" y="277180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15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正方形/長方形 46"/>
            <p:cNvSpPr/>
            <p:nvPr/>
          </p:nvSpPr>
          <p:spPr>
            <a:xfrm>
              <a:off x="980728" y="1043608"/>
              <a:ext cx="1080120" cy="25202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右大かっこ 47"/>
            <p:cNvSpPr/>
            <p:nvPr/>
          </p:nvSpPr>
          <p:spPr>
            <a:xfrm>
              <a:off x="2132856" y="1403648"/>
              <a:ext cx="45719" cy="864096"/>
            </a:xfrm>
            <a:prstGeom prst="rightBracket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2132856" y="1619672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CtMex67</a:t>
              </a:r>
            </a:p>
            <a:p>
              <a:pPr algn="ctr"/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fragments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2243462" y="2339752"/>
              <a:ext cx="6463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476672" y="683568"/>
              <a:ext cx="5597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M.W.</a:t>
              </a:r>
            </a:p>
            <a:p>
              <a:pPr algn="ctr"/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ja-JP" sz="1200" dirty="0" err="1" smtClean="0">
                  <a:latin typeface="Arial" pitchFamily="34" charset="0"/>
                  <a:cs typeface="Arial" pitchFamily="34" charset="0"/>
                </a:rPr>
                <a:t>kDa</a:t>
              </a:r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1196752" y="356388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484784" y="356388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772816" y="356388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グループ化 70"/>
          <p:cNvGrpSpPr/>
          <p:nvPr/>
        </p:nvGrpSpPr>
        <p:grpSpPr>
          <a:xfrm>
            <a:off x="2564904" y="1691680"/>
            <a:ext cx="4302963" cy="3528392"/>
            <a:chOff x="908720" y="4644008"/>
            <a:chExt cx="4302963" cy="3528392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501008" y="5220072"/>
              <a:ext cx="957838" cy="27727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6" name="Picture 2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124744" y="5195823"/>
              <a:ext cx="1228800" cy="27803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7" name="Picture 3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420888" y="5195823"/>
              <a:ext cx="1066770" cy="28325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正方形/長方形 7"/>
            <p:cNvSpPr/>
            <p:nvPr/>
          </p:nvSpPr>
          <p:spPr>
            <a:xfrm>
              <a:off x="908720" y="7884368"/>
              <a:ext cx="3816424" cy="2160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直角三角形 9"/>
            <p:cNvSpPr/>
            <p:nvPr/>
          </p:nvSpPr>
          <p:spPr>
            <a:xfrm flipH="1">
              <a:off x="1340768" y="4932040"/>
              <a:ext cx="936104" cy="288032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直角三角形 10"/>
            <p:cNvSpPr/>
            <p:nvPr/>
          </p:nvSpPr>
          <p:spPr>
            <a:xfrm flipH="1">
              <a:off x="2420888" y="4932040"/>
              <a:ext cx="936104" cy="288032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直角三角形 11"/>
            <p:cNvSpPr/>
            <p:nvPr/>
          </p:nvSpPr>
          <p:spPr>
            <a:xfrm flipH="1">
              <a:off x="3501008" y="4932040"/>
              <a:ext cx="936104" cy="288032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151166" y="4932040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>
                  <a:latin typeface="Arial" pitchFamily="34" charset="0"/>
                  <a:cs typeface="Arial" pitchFamily="34" charset="0"/>
                </a:rPr>
                <a:t>-</a:t>
              </a:r>
              <a:endParaRPr kumimoji="1" lang="ja-JP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2536921" y="4644008"/>
              <a:ext cx="7040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70-657/</a:t>
              </a:r>
            </a:p>
            <a:p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1414321" y="4644008"/>
              <a:ext cx="78899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365-564/</a:t>
              </a:r>
            </a:p>
            <a:p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3638681" y="4736341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93-360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4437112" y="7361148"/>
              <a:ext cx="7745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 err="1" smtClean="0"/>
                <a:t>Halfmer</a:t>
              </a:r>
              <a:endParaRPr kumimoji="1" lang="en-US" altLang="ja-JP" sz="1400" dirty="0" smtClean="0"/>
            </a:p>
            <a:p>
              <a:pPr algn="ctr"/>
              <a:r>
                <a:rPr lang="en-US" altLang="ja-JP" sz="1400" dirty="0" smtClean="0"/>
                <a:t>CTE</a:t>
              </a:r>
              <a:endParaRPr kumimoji="1" lang="ja-JP" altLang="en-US" sz="1400" dirty="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1124744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1340768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1509602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1700808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1916832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2085666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2348880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7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2564904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8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2780928" y="791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9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2924944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0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3140968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1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3447280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2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3645024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3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3807320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4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4005064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5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4167360" y="791079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16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グループ化 72"/>
          <p:cNvGrpSpPr/>
          <p:nvPr/>
        </p:nvGrpSpPr>
        <p:grpSpPr>
          <a:xfrm>
            <a:off x="548680" y="467544"/>
            <a:ext cx="5532876" cy="576064"/>
            <a:chOff x="836712" y="251520"/>
            <a:chExt cx="5532876" cy="576064"/>
          </a:xfrm>
        </p:grpSpPr>
        <p:grpSp>
          <p:nvGrpSpPr>
            <p:cNvPr id="6" name="グループ化 92"/>
            <p:cNvGrpSpPr/>
            <p:nvPr/>
          </p:nvGrpSpPr>
          <p:grpSpPr>
            <a:xfrm>
              <a:off x="836712" y="251520"/>
              <a:ext cx="5532876" cy="405626"/>
              <a:chOff x="836712" y="899592"/>
              <a:chExt cx="5532876" cy="405626"/>
            </a:xfrm>
          </p:grpSpPr>
          <p:cxnSp>
            <p:nvCxnSpPr>
              <p:cNvPr id="77" name="直線コネクタ 76"/>
              <p:cNvCxnSpPr/>
              <p:nvPr/>
            </p:nvCxnSpPr>
            <p:spPr>
              <a:xfrm>
                <a:off x="980728" y="1174413"/>
                <a:ext cx="518457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正方形/長方形 77"/>
              <p:cNvSpPr/>
              <p:nvPr/>
            </p:nvSpPr>
            <p:spPr>
              <a:xfrm>
                <a:off x="1268760" y="1102405"/>
                <a:ext cx="576064" cy="14401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9" name="正方形/長方形 78"/>
              <p:cNvSpPr/>
              <p:nvPr/>
            </p:nvSpPr>
            <p:spPr>
              <a:xfrm>
                <a:off x="2060848" y="1102405"/>
                <a:ext cx="1368152" cy="14401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0" name="正方形/長方形 79"/>
              <p:cNvSpPr/>
              <p:nvPr/>
            </p:nvSpPr>
            <p:spPr>
              <a:xfrm>
                <a:off x="3717032" y="1102405"/>
                <a:ext cx="1296144" cy="144016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1" name="正方形/長方形 80"/>
              <p:cNvSpPr/>
              <p:nvPr/>
            </p:nvSpPr>
            <p:spPr>
              <a:xfrm>
                <a:off x="5157192" y="1102405"/>
                <a:ext cx="576064" cy="144016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>
                <a:off x="1303357" y="1043608"/>
                <a:ext cx="506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>
                    <a:latin typeface="Arial" pitchFamily="34" charset="0"/>
                    <a:cs typeface="Arial" pitchFamily="34" charset="0"/>
                  </a:rPr>
                  <a:t>RRM</a:t>
                </a:r>
                <a:endParaRPr kumimoji="1" lang="ja-JP" altLang="en-US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>
                <a:off x="2506718" y="1043608"/>
                <a:ext cx="4764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LRR</a:t>
                </a:r>
                <a:endParaRPr kumimoji="1" lang="ja-JP" altLang="en-US" sz="11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>
                <a:off x="4052358" y="1043608"/>
                <a:ext cx="6254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NTF2L</a:t>
                </a:r>
                <a:endParaRPr kumimoji="1" lang="ja-JP" altLang="en-US" sz="11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>
                <a:off x="5199003" y="1043608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>
                    <a:latin typeface="Arial" pitchFamily="34" charset="0"/>
                    <a:cs typeface="Arial" pitchFamily="34" charset="0"/>
                  </a:rPr>
                  <a:t>UBA</a:t>
                </a:r>
                <a:endParaRPr kumimoji="1" lang="ja-JP" altLang="en-US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テキスト ボックス 85"/>
              <p:cNvSpPr txBox="1"/>
              <p:nvPr/>
            </p:nvSpPr>
            <p:spPr>
              <a:xfrm>
                <a:off x="836712" y="89959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kumimoji="1" lang="ja-JP" alt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>
                <a:off x="1052736" y="89959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itchFamily="34" charset="0"/>
                    <a:cs typeface="Arial" pitchFamily="34" charset="0"/>
                  </a:rPr>
                  <a:t>93</a:t>
                </a:r>
                <a:endParaRPr kumimoji="1" lang="ja-JP" alt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>
                <a:off x="3140968" y="89959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itchFamily="34" charset="0"/>
                    <a:cs typeface="Arial" pitchFamily="34" charset="0"/>
                  </a:rPr>
                  <a:t>360</a:t>
                </a:r>
                <a:endParaRPr kumimoji="1" lang="ja-JP" alt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>
                <a:off x="3501008" y="89959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itchFamily="34" charset="0"/>
                    <a:cs typeface="Arial" pitchFamily="34" charset="0"/>
                  </a:rPr>
                  <a:t>365</a:t>
                </a:r>
                <a:endParaRPr kumimoji="1" lang="ja-JP" alt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テキスト ボックス 89"/>
              <p:cNvSpPr txBox="1"/>
              <p:nvPr/>
            </p:nvSpPr>
            <p:spPr>
              <a:xfrm>
                <a:off x="4797152" y="89959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itchFamily="34" charset="0"/>
                    <a:cs typeface="Arial" pitchFamily="34" charset="0"/>
                  </a:rPr>
                  <a:t>564</a:t>
                </a:r>
                <a:endParaRPr kumimoji="1" lang="ja-JP" alt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テキスト ボックス 90"/>
              <p:cNvSpPr txBox="1"/>
              <p:nvPr/>
            </p:nvSpPr>
            <p:spPr>
              <a:xfrm>
                <a:off x="5949280" y="89959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itchFamily="34" charset="0"/>
                    <a:cs typeface="Arial" pitchFamily="34" charset="0"/>
                  </a:rPr>
                  <a:t>657</a:t>
                </a:r>
                <a:endParaRPr kumimoji="1" lang="ja-JP" alt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5" name="角丸四角形 74"/>
            <p:cNvSpPr/>
            <p:nvPr/>
          </p:nvSpPr>
          <p:spPr>
            <a:xfrm>
              <a:off x="3717032" y="624771"/>
              <a:ext cx="1296144" cy="144016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4061976" y="565974"/>
              <a:ext cx="6062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C</a:t>
              </a:r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tMtr2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3" name="テキスト ボックス 92"/>
          <p:cNvSpPr txBox="1"/>
          <p:nvPr/>
        </p:nvSpPr>
        <p:spPr>
          <a:xfrm>
            <a:off x="238593" y="17022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238593" y="125963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492896" y="12596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グループ化 102"/>
          <p:cNvGrpSpPr/>
          <p:nvPr/>
        </p:nvGrpSpPr>
        <p:grpSpPr>
          <a:xfrm>
            <a:off x="548680" y="5580112"/>
            <a:ext cx="4896544" cy="3116089"/>
            <a:chOff x="404664" y="5704383"/>
            <a:chExt cx="4896544" cy="3116089"/>
          </a:xfrm>
        </p:grpSpPr>
        <p:graphicFrame>
          <p:nvGraphicFramePr>
            <p:cNvPr id="92" name="グラフ 91"/>
            <p:cNvGraphicFramePr/>
            <p:nvPr/>
          </p:nvGraphicFramePr>
          <p:xfrm>
            <a:off x="568425" y="5704383"/>
            <a:ext cx="4732783" cy="29523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96" name="テキスト ボックス 95"/>
            <p:cNvSpPr txBox="1"/>
            <p:nvPr/>
          </p:nvSpPr>
          <p:spPr>
            <a:xfrm>
              <a:off x="2368625" y="8512695"/>
              <a:ext cx="17363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Protein Conc. (</a:t>
              </a:r>
              <a:r>
                <a:rPr kumimoji="1" lang="en-US" altLang="ja-JP" sz="1400" dirty="0" err="1" smtClean="0">
                  <a:latin typeface="Symbol" pitchFamily="18" charset="2"/>
                  <a:cs typeface="Arial" pitchFamily="34" charset="0"/>
                </a:rPr>
                <a:t>m</a:t>
              </a:r>
              <a:r>
                <a:rPr kumimoji="1" lang="en-US" altLang="ja-JP" sz="1400" dirty="0" err="1" smtClean="0">
                  <a:latin typeface="Arial" pitchFamily="34" charset="0"/>
                  <a:cs typeface="Arial" pitchFamily="34" charset="0"/>
                </a:rPr>
                <a:t>M</a:t>
              </a:r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テキスト ボックス 96"/>
            <p:cNvSpPr txBox="1"/>
            <p:nvPr/>
          </p:nvSpPr>
          <p:spPr>
            <a:xfrm rot="16200000" flipH="1">
              <a:off x="41352" y="6859783"/>
              <a:ext cx="10344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 smtClean="0">
                  <a:latin typeface="Arial" pitchFamily="34" charset="0"/>
                  <a:cs typeface="Arial" pitchFamily="34" charset="0"/>
                </a:rPr>
                <a:t>% Bound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テキスト ボックス 97"/>
            <p:cNvSpPr txBox="1"/>
            <p:nvPr/>
          </p:nvSpPr>
          <p:spPr>
            <a:xfrm>
              <a:off x="1216497" y="5848399"/>
              <a:ext cx="1165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70-657/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2780928" y="5920407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365-564/CtMtr2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テキスト ボックス 99"/>
            <p:cNvSpPr txBox="1"/>
            <p:nvPr/>
          </p:nvSpPr>
          <p:spPr>
            <a:xfrm>
              <a:off x="4365104" y="6280447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93-360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2" name="テキスト ボックス 101"/>
          <p:cNvSpPr txBox="1"/>
          <p:nvPr/>
        </p:nvSpPr>
        <p:spPr>
          <a:xfrm>
            <a:off x="232181" y="53640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D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27"/>
          <p:cNvGrpSpPr/>
          <p:nvPr/>
        </p:nvGrpSpPr>
        <p:grpSpPr>
          <a:xfrm>
            <a:off x="2820197" y="827584"/>
            <a:ext cx="3035589" cy="5747410"/>
            <a:chOff x="3561763" y="827584"/>
            <a:chExt cx="3035589" cy="5747410"/>
          </a:xfrm>
        </p:grpSpPr>
        <p:pic>
          <p:nvPicPr>
            <p:cNvPr id="6" name="図 5" descr="DsR#2.tif"/>
            <p:cNvPicPr preferRelativeResize="0"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54152" y="827584"/>
              <a:ext cx="2743200" cy="1363134"/>
            </a:xfrm>
            <a:prstGeom prst="rect">
              <a:avLst/>
            </a:prstGeom>
          </p:spPr>
        </p:pic>
        <p:pic>
          <p:nvPicPr>
            <p:cNvPr id="7" name="図 6" descr="Aly#2.tif"/>
            <p:cNvPicPr preferRelativeResize="0"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854152" y="3707904"/>
              <a:ext cx="2743200" cy="1363134"/>
            </a:xfrm>
            <a:prstGeom prst="rect">
              <a:avLst/>
            </a:prstGeom>
          </p:spPr>
        </p:pic>
        <p:pic>
          <p:nvPicPr>
            <p:cNvPr id="8" name="図 7" descr="Ano#3.tif"/>
            <p:cNvPicPr preferRelativeResize="0"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854152" y="2272762"/>
              <a:ext cx="2743200" cy="1363134"/>
            </a:xfrm>
            <a:prstGeom prst="rect">
              <a:avLst/>
            </a:prstGeom>
          </p:spPr>
        </p:pic>
        <p:pic>
          <p:nvPicPr>
            <p:cNvPr id="9" name="図 8" descr="DKD#3.tif"/>
            <p:cNvPicPr preferRelativeResize="0"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854152" y="5150274"/>
              <a:ext cx="2743200" cy="1363134"/>
            </a:xfrm>
            <a:prstGeom prst="rect">
              <a:avLst/>
            </a:prstGeom>
          </p:spPr>
        </p:pic>
        <p:sp>
          <p:nvSpPr>
            <p:cNvPr id="10" name="テキスト ボックス 9"/>
            <p:cNvSpPr txBox="1"/>
            <p:nvPr/>
          </p:nvSpPr>
          <p:spPr>
            <a:xfrm rot="16200000">
              <a:off x="3318588" y="1370652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Arial" pitchFamily="34" charset="0"/>
                  <a:cs typeface="Arial" pitchFamily="34" charset="0"/>
                </a:rPr>
                <a:t>siDsRed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 rot="16200000">
              <a:off x="3271876" y="4250972"/>
              <a:ext cx="8567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Arial" pitchFamily="34" charset="0"/>
                  <a:cs typeface="Arial" pitchFamily="34" charset="0"/>
                </a:rPr>
                <a:t>siAyl</a:t>
              </a:r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/REF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 rot="16200000">
              <a:off x="3339427" y="2815830"/>
              <a:ext cx="721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siThoc5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 rot="16200000">
              <a:off x="2957111" y="5693342"/>
              <a:ext cx="1486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Arial" pitchFamily="34" charset="0"/>
                  <a:cs typeface="Arial" pitchFamily="34" charset="0"/>
                </a:rPr>
                <a:t>siAly</a:t>
              </a:r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/REF+siThoc5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テキスト ボックス 14"/>
          <p:cNvSpPr txBox="1"/>
          <p:nvPr/>
        </p:nvSpPr>
        <p:spPr>
          <a:xfrm>
            <a:off x="138118" y="5035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420888" y="5035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221088" y="-36512"/>
            <a:ext cx="2669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upplementary Figure S2. Katahira et al.</a:t>
            </a:r>
            <a:endParaRPr kumimoji="1" lang="ja-JP" altLang="en-US" sz="1200" dirty="0"/>
          </a:p>
        </p:txBody>
      </p:sp>
      <p:grpSp>
        <p:nvGrpSpPr>
          <p:cNvPr id="3" name="グループ化 32"/>
          <p:cNvGrpSpPr/>
          <p:nvPr/>
        </p:nvGrpSpPr>
        <p:grpSpPr>
          <a:xfrm>
            <a:off x="548680" y="412882"/>
            <a:ext cx="1728192" cy="2430926"/>
            <a:chOff x="764704" y="1049921"/>
            <a:chExt cx="1728192" cy="243092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764704" y="2411760"/>
              <a:ext cx="1022350" cy="1825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64705" y="2699792"/>
              <a:ext cx="1008111" cy="2241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764704" y="3275856"/>
              <a:ext cx="1008000" cy="1726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764704" y="2987825"/>
              <a:ext cx="1008000" cy="1809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" name="正方形/長方形 19"/>
            <p:cNvSpPr/>
            <p:nvPr/>
          </p:nvSpPr>
          <p:spPr>
            <a:xfrm>
              <a:off x="764704" y="2411760"/>
              <a:ext cx="1008112" cy="18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764704" y="2699792"/>
              <a:ext cx="1008112" cy="2160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764704" y="2987824"/>
              <a:ext cx="1008112" cy="18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764704" y="3275856"/>
              <a:ext cx="1008112" cy="18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テキスト ボックス 23"/>
            <p:cNvSpPr txBox="1"/>
            <p:nvPr/>
          </p:nvSpPr>
          <p:spPr>
            <a:xfrm rot="18296756">
              <a:off x="612242" y="1953078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Arial" pitchFamily="34" charset="0"/>
                  <a:cs typeface="Arial" pitchFamily="34" charset="0"/>
                </a:rPr>
                <a:t>siDsRed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 rot="18296756">
              <a:off x="1127368" y="1901749"/>
              <a:ext cx="8595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Arial" pitchFamily="34" charset="0"/>
                  <a:cs typeface="Arial" pitchFamily="34" charset="0"/>
                </a:rPr>
                <a:t>siAly</a:t>
              </a:r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/REF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 rot="18296756">
              <a:off x="947748" y="1970160"/>
              <a:ext cx="721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siThoc5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 rot="18296756">
              <a:off x="1282545" y="1654573"/>
              <a:ext cx="1486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Arial" pitchFamily="34" charset="0"/>
                  <a:cs typeface="Arial" pitchFamily="34" charset="0"/>
                </a:rPr>
                <a:t>siAly</a:t>
              </a:r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/REF+siThoc5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902381" y="2350785"/>
              <a:ext cx="432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Tap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812902" y="2627784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Thoc5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1743973" y="2915816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Aly/REF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1752789" y="3203848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2</Words>
  <Application>Microsoft Office PowerPoint</Application>
  <PresentationFormat>画面に合わせる (4:3)</PresentationFormat>
  <Paragraphs>77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スライド 1</vt:lpstr>
      <vt:lpstr>スライド 2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SER</dc:creator>
  <cp:lastModifiedBy>USER</cp:lastModifiedBy>
  <cp:revision>5</cp:revision>
  <dcterms:created xsi:type="dcterms:W3CDTF">2014-11-21T01:41:04Z</dcterms:created>
  <dcterms:modified xsi:type="dcterms:W3CDTF">2015-01-05T01:15:45Z</dcterms:modified>
</cp:coreProperties>
</file>